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601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150" d="100"/>
          <a:sy n="150" d="100"/>
        </p:scale>
        <p:origin x="1476" y="-21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1212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7767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84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397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5547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642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6767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863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4760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8170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5968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4A533-FB26-49CB-BC9D-1853AAE4E165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5ACF2-F7AF-48FB-9B94-625B324FA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0797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Mut_eGFP_ZO1_594_Hoescht_405_X40 8 h zstack-movie (5)">
            <a:hlinkClick r:id="" action="ppaction://media"/>
            <a:extLst>
              <a:ext uri="{FF2B5EF4-FFF2-40B4-BE49-F238E27FC236}">
                <a16:creationId xmlns:a16="http://schemas.microsoft.com/office/drawing/2014/main" id="{BF5E3316-932E-4E78-9956-16A02B44A3B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2279" t="-968" r="725" b="-1"/>
          <a:stretch/>
        </p:blipFill>
        <p:spPr>
          <a:xfrm>
            <a:off x="1489587" y="2300748"/>
            <a:ext cx="3941916" cy="307749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54EB1FA-DCB9-4273-89FB-A95F04F3FB86}"/>
              </a:ext>
            </a:extLst>
          </p:cNvPr>
          <p:cNvSpPr txBox="1"/>
          <p:nvPr/>
        </p:nvSpPr>
        <p:spPr>
          <a:xfrm>
            <a:off x="1489587" y="2021546"/>
            <a:ext cx="3941916" cy="307777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0601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GB" sz="1400" dirty="0">
                <a:solidFill>
                  <a:srgbClr val="21F8F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O-1 </a:t>
            </a:r>
            <a:r>
              <a:rPr lang="en-GB" sz="1400" dirty="0">
                <a:solidFill>
                  <a:srgbClr val="24FF7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r>
              <a:rPr lang="en-GB" sz="1400" dirty="0" err="1">
                <a:solidFill>
                  <a:srgbClr val="24FF7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endParaRPr lang="en-GB" sz="1400" dirty="0">
              <a:solidFill>
                <a:srgbClr val="24FF7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8570F00-BC98-4217-86F3-AEFC4E1950C9}"/>
              </a:ext>
            </a:extLst>
          </p:cNvPr>
          <p:cNvSpPr txBox="1"/>
          <p:nvPr/>
        </p:nvSpPr>
        <p:spPr>
          <a:xfrm>
            <a:off x="1489587" y="2329323"/>
            <a:ext cx="1038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deo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0ACC5DD-1422-408F-9DF7-822F9817CA31}"/>
              </a:ext>
            </a:extLst>
          </p:cNvPr>
          <p:cNvSpPr txBox="1"/>
          <p:nvPr/>
        </p:nvSpPr>
        <p:spPr>
          <a:xfrm>
            <a:off x="4371496" y="5101246"/>
            <a:ext cx="1352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al Region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7F451C-8B8B-41EB-B068-042BD4A34E75}"/>
              </a:ext>
            </a:extLst>
          </p:cNvPr>
          <p:cNvSpPr txBox="1"/>
          <p:nvPr/>
        </p:nvSpPr>
        <p:spPr>
          <a:xfrm>
            <a:off x="4330184" y="2421656"/>
            <a:ext cx="13242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ical Region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CD357E4-C730-4B34-882C-8583A7B20624}"/>
              </a:ext>
            </a:extLst>
          </p:cNvPr>
          <p:cNvSpPr txBox="1"/>
          <p:nvPr/>
        </p:nvSpPr>
        <p:spPr>
          <a:xfrm>
            <a:off x="1370309" y="5865167"/>
            <a:ext cx="42841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3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.T infected 2D enteroids, altering the localisation of ZO-1 expression. </a:t>
            </a:r>
          </a:p>
        </p:txBody>
      </p:sp>
    </p:spTree>
    <p:extLst>
      <p:ext uri="{BB962C8B-B14F-4D97-AF65-F5344CB8AC3E}">
        <p14:creationId xmlns:p14="http://schemas.microsoft.com/office/powerpoint/2010/main" val="357857070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04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29</Words>
  <Application>Microsoft Office PowerPoint</Application>
  <PresentationFormat>Widescreen</PresentationFormat>
  <Paragraphs>5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Sutton</dc:creator>
  <cp:lastModifiedBy>Kate Sutton</cp:lastModifiedBy>
  <cp:revision>1</cp:revision>
  <dcterms:created xsi:type="dcterms:W3CDTF">2023-09-18T16:29:48Z</dcterms:created>
  <dcterms:modified xsi:type="dcterms:W3CDTF">2023-09-18T16:38:18Z</dcterms:modified>
</cp:coreProperties>
</file>